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8" r:id="rId2"/>
  </p:sldIdLst>
  <p:sldSz cx="12192000" cy="6858000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3D33-04CE-43FD-8DF0-07522D243BAD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7C43-7C55-44A2-B91C-D575525A652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066774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3D33-04CE-43FD-8DF0-07522D243BAD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7C43-7C55-44A2-B91C-D575525A652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0029950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3D33-04CE-43FD-8DF0-07522D243BAD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7C43-7C55-44A2-B91C-D575525A652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3537690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3D33-04CE-43FD-8DF0-07522D243BAD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7C43-7C55-44A2-B91C-D575525A652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4107937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3D33-04CE-43FD-8DF0-07522D243BAD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7C43-7C55-44A2-B91C-D575525A652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78271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3D33-04CE-43FD-8DF0-07522D243BAD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7C43-7C55-44A2-B91C-D575525A652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0890583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3D33-04CE-43FD-8DF0-07522D243BAD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7C43-7C55-44A2-B91C-D575525A652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1913072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3D33-04CE-43FD-8DF0-07522D243BAD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7C43-7C55-44A2-B91C-D575525A652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9147385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3D33-04CE-43FD-8DF0-07522D243BAD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7C43-7C55-44A2-B91C-D575525A652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8115496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3D33-04CE-43FD-8DF0-07522D243BAD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7C43-7C55-44A2-B91C-D575525A652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0109831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3D33-04CE-43FD-8DF0-07522D243BAD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7C43-7C55-44A2-B91C-D575525A652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1493197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213D33-04CE-43FD-8DF0-07522D243BAD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547C43-7C55-44A2-B91C-D575525A652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572114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a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93316186"/>
              </p:ext>
            </p:extLst>
          </p:nvPr>
        </p:nvGraphicFramePr>
        <p:xfrm>
          <a:off x="2955234" y="357802"/>
          <a:ext cx="5261114" cy="5883972"/>
        </p:xfrm>
        <a:graphic>
          <a:graphicData uri="http://schemas.openxmlformats.org/drawingml/2006/table">
            <a:tbl>
              <a:tblPr firstRow="1" firstCol="1" bandRow="1"/>
              <a:tblGrid>
                <a:gridCol w="2059629">
                  <a:extLst>
                    <a:ext uri="{9D8B030D-6E8A-4147-A177-3AD203B41FA5}">
                      <a16:colId xmlns:a16="http://schemas.microsoft.com/office/drawing/2014/main" val="2008959087"/>
                    </a:ext>
                  </a:extLst>
                </a:gridCol>
                <a:gridCol w="1449965">
                  <a:extLst>
                    <a:ext uri="{9D8B030D-6E8A-4147-A177-3AD203B41FA5}">
                      <a16:colId xmlns:a16="http://schemas.microsoft.com/office/drawing/2014/main" val="526841972"/>
                    </a:ext>
                  </a:extLst>
                </a:gridCol>
                <a:gridCol w="1751520">
                  <a:extLst>
                    <a:ext uri="{9D8B030D-6E8A-4147-A177-3AD203B41FA5}">
                      <a16:colId xmlns:a16="http://schemas.microsoft.com/office/drawing/2014/main" val="1748916224"/>
                    </a:ext>
                  </a:extLst>
                </a:gridCol>
              </a:tblGrid>
              <a:tr h="23535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nsulin sensitivity indexes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OC Curve Area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95% Conf. Interval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99501102"/>
                  </a:ext>
                </a:extLst>
              </a:tr>
              <a:tr h="23535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TSUDA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4867422"/>
                  </a:ext>
                </a:extLst>
              </a:tr>
              <a:tr h="23535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eptin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73</a:t>
                      </a:r>
                      <a:endParaRPr lang="es-CL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60 - 0.86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1777446"/>
                  </a:ext>
                </a:extLst>
              </a:tr>
              <a:tr h="23535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otal Adiponectin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65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50 - 0.79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4051860"/>
                  </a:ext>
                </a:extLst>
              </a:tr>
              <a:tr h="47071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igh-Molecular Weight Adiponectin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59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44 - 0.73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1579191"/>
                  </a:ext>
                </a:extLst>
              </a:tr>
              <a:tr h="23535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AR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75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62 - 0.88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1464179"/>
                  </a:ext>
                </a:extLst>
              </a:tr>
              <a:tr h="23535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eptin/HMWA ratio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72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58 - 0.86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0552579"/>
                  </a:ext>
                </a:extLst>
              </a:tr>
              <a:tr h="23535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 value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2185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2933980"/>
                  </a:ext>
                </a:extLst>
              </a:tr>
              <a:tr h="23535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Si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6646406"/>
                  </a:ext>
                </a:extLst>
              </a:tr>
              <a:tr h="23535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eptin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61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45 - 0.77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5172708"/>
                  </a:ext>
                </a:extLst>
              </a:tr>
              <a:tr h="23535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otal Adiponectin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74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59 - 0.88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3045991"/>
                  </a:ext>
                </a:extLst>
              </a:tr>
              <a:tr h="47071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igh-Molecular Weight Adiponectin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66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51 - 0.82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9932392"/>
                  </a:ext>
                </a:extLst>
              </a:tr>
              <a:tr h="23535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AR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70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56 - 0.85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7223009"/>
                  </a:ext>
                </a:extLst>
              </a:tr>
              <a:tr h="23535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eptin/HMWA ratio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68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53 - 0.83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5009591"/>
                  </a:ext>
                </a:extLst>
              </a:tr>
              <a:tr h="23535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 value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1556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1679329"/>
                  </a:ext>
                </a:extLst>
              </a:tr>
              <a:tr h="23535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OMA-S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7503183"/>
                  </a:ext>
                </a:extLst>
              </a:tr>
              <a:tr h="23535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eptin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70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57 - 0.84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2153198"/>
                  </a:ext>
                </a:extLst>
              </a:tr>
              <a:tr h="23535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otal Adiponectin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62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48 - 0.77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4368527"/>
                  </a:ext>
                </a:extLst>
              </a:tr>
              <a:tr h="47071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igh-Molecular Weight Adiponectin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63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49 - 0.78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6360913"/>
                  </a:ext>
                </a:extLst>
              </a:tr>
              <a:tr h="23535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AR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71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58 - 0.85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5087106"/>
                  </a:ext>
                </a:extLst>
              </a:tr>
              <a:tr h="23535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eptin/HMWA ratio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72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59 - 0.85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5865324"/>
                  </a:ext>
                </a:extLst>
              </a:tr>
              <a:tr h="23535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 value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4209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942" marR="5394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6270158"/>
                  </a:ext>
                </a:extLst>
              </a:tr>
            </a:tbl>
          </a:graphicData>
        </a:graphic>
      </p:graphicFrame>
      <p:sp>
        <p:nvSpPr>
          <p:cNvPr id="4" name="CuadroTexto 3"/>
          <p:cNvSpPr txBox="1"/>
          <p:nvPr/>
        </p:nvSpPr>
        <p:spPr>
          <a:xfrm>
            <a:off x="7818783" y="6241774"/>
            <a:ext cx="2994991" cy="3710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 err="1"/>
              <a:t>Table</a:t>
            </a:r>
            <a:r>
              <a:rPr lang="es-CL" dirty="0"/>
              <a:t> 2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343552220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</TotalTime>
  <Words>114</Words>
  <Application>Microsoft Office PowerPoint</Application>
  <PresentationFormat>Panorámica</PresentationFormat>
  <Paragraphs>67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ito Bravo</dc:creator>
  <cp:lastModifiedBy>Carito Bravo</cp:lastModifiedBy>
  <cp:revision>7</cp:revision>
  <dcterms:created xsi:type="dcterms:W3CDTF">2017-03-27T13:54:06Z</dcterms:created>
  <dcterms:modified xsi:type="dcterms:W3CDTF">2017-03-27T14:51:04Z</dcterms:modified>
</cp:coreProperties>
</file>